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72" r:id="rId3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3BBCDFC-5E15-41AF-8F69-EE60783CF4A7}" v="1" dt="2025-09-22T09:27:42.6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0" d="100"/>
          <a:sy n="80" d="100"/>
        </p:scale>
        <p:origin x="619" y="-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93BBCDFC-5E15-41AF-8F69-EE60783CF4A7}"/>
    <pc:docChg chg="modSld">
      <pc:chgData name="Laycock, Joseph" userId="c4bfcbf4-3ccc-440e-b317-559baf184f0d" providerId="ADAL" clId="{93BBCDFC-5E15-41AF-8F69-EE60783CF4A7}" dt="2025-09-22T09:28:31.558" v="7" actId="1036"/>
      <pc:docMkLst>
        <pc:docMk/>
      </pc:docMkLst>
      <pc:sldChg chg="modSp mod">
        <pc:chgData name="Laycock, Joseph" userId="c4bfcbf4-3ccc-440e-b317-559baf184f0d" providerId="ADAL" clId="{93BBCDFC-5E15-41AF-8F69-EE60783CF4A7}" dt="2025-09-22T09:28:31.558" v="7" actId="1036"/>
        <pc:sldMkLst>
          <pc:docMk/>
          <pc:sldMk cId="4048924459" sldId="272"/>
        </pc:sldMkLst>
        <pc:spChg chg="mod">
          <ac:chgData name="Laycock, Joseph" userId="c4bfcbf4-3ccc-440e-b317-559baf184f0d" providerId="ADAL" clId="{93BBCDFC-5E15-41AF-8F69-EE60783CF4A7}" dt="2025-09-22T09:27:42.685" v="0"/>
          <ac:spMkLst>
            <pc:docMk/>
            <pc:sldMk cId="4048924459" sldId="272"/>
            <ac:spMk id="2" creationId="{8973074A-3CDC-A8C7-3846-9C3168BA6FCE}"/>
          </ac:spMkLst>
        </pc:spChg>
        <pc:spChg chg="mod">
          <ac:chgData name="Laycock, Joseph" userId="c4bfcbf4-3ccc-440e-b317-559baf184f0d" providerId="ADAL" clId="{93BBCDFC-5E15-41AF-8F69-EE60783CF4A7}" dt="2025-09-22T09:28:31.558" v="7" actId="1036"/>
          <ac:spMkLst>
            <pc:docMk/>
            <pc:sldMk cId="4048924459" sldId="272"/>
            <ac:spMk id="4" creationId="{767110FE-CFDF-BF93-A923-3253F9E75B2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ACFB94-FDD0-00D4-87D2-E0D208AC52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9B61E562-7B36-6D66-3E10-6ECEBAC8F2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8D99207-48E8-149C-3E1D-123786769A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62ED07B-6C9B-CDE8-B354-B81EAA7DB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D63EA94-91E1-4F5E-7738-8FDC6BD6B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70019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6508060-1F36-D2C6-5CEF-C0D2893C84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6AAB66FB-FA6A-B946-D23B-B81E4E260D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6D8E744-561B-8A88-0059-E4B0CEB63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529DF79D-C3D4-CC59-4C81-BB39F0E04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8B0F386-86F5-70CE-15EB-F5DB71B6F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96452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B76A9A53-C6B2-663C-D66F-80BC233B04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0BEEDD26-FF8F-CD7C-6190-79A8D020FE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0EED697-89DF-DA03-6103-33EB3485E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909F30B1-B033-65DF-8538-698B2D00E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34953D6-5BFA-4C57-A391-54AE233323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2895841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00405028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68144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60239234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54337415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21723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963549E-83A7-9E4C-D3B2-4E36EBA03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6BCC8FA-4F45-A4A0-27B0-8846BC6ABC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D9C435E9-ACD3-BB58-9CFA-73B3E8891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98AB6891-F14F-2A62-50F7-8F91DF3B7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C17E906-F890-70A3-0018-C49984B41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45471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99A7E75-4959-4451-DC6C-70642E12F2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F6E9BC55-AE5F-FF32-4CB8-A6A36ACC6B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BF2E235-907F-7FB4-B45F-6F125AB34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16AAAADD-79F1-6765-DF2D-F9D1E893B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F0571CD1-F84C-9FF5-D77C-3C6D683A6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0353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965B0AA-6678-7C84-C8EF-C228D728B1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B8926D5-EBB5-5F39-D559-A15FBC38ED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541125CF-3974-C3FF-35A8-2BEF9EE81F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F9FC055C-993A-3357-9C78-F37E00A53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3FD271FD-4C59-F8C1-63FB-AEE402DAB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874F0ECE-148E-2F9E-4043-0E2DCE7C7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04138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7CA2B8-2D97-967E-3E44-73864D0DC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C7D405C2-A79E-A53C-CB0E-817A345B65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67795098-1A53-1B80-FE69-D6E8E4613F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E592FFC2-A016-F2F2-6849-2C72A60553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1E19E8BF-625B-F396-99B6-13712AB8A9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1AE8920C-70BA-C70E-4A6D-DBA4C263B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EDDB8A20-882B-3D12-7D96-683EBB6C8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2B64113A-8390-5F69-6850-D96031854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85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A78CA6D-7709-EECB-5C56-BE11E7CAD8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BDA018DC-83ED-7C7C-596C-309884E0B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1A0B5F0B-43C1-4299-649C-E325F26CE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684EDEFD-6210-260E-95E4-7F10D8371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28806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616007C4-90B1-BD7B-D034-5E1A2C6FD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EEBEE4E5-0847-F905-C2D1-161F53060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32BF7858-C1DD-815C-7F86-7EDF0EEB3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8417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4AC5CB5-C58D-0B5C-6883-E24451A292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18E99940-AD08-4169-D973-B969372965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7FD1BC35-58DD-7107-9A86-F7ABDF5412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96CA97D-35AA-BE28-CEC9-185D6BBEA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12FBCE8A-17F0-BA37-DC30-06F3B2D64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D3E54C48-F302-B7D5-2A89-9B4883577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87019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3CA89C9-745F-445E-36C2-EC3BD117F8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94283B02-4FDF-8A01-ABC4-0CD77EC083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25B5FE37-63C4-9591-EE3D-C6FDB1B11B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7E616AD2-BA5C-E305-4F2F-0D21E17E0E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8FD1A5DF-9728-58CF-911B-C1EFA8922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882BFE6D-A506-186B-641D-DFD1803FE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47910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4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9318D804-09C9-BA88-7ADC-9E2AF0374F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1B6FE937-F646-50FD-BB3A-E803B1EF0D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E163E288-AE3A-98AE-90A1-E6E8939A83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88265C-7B07-48CE-866E-A6312968EB5C}" type="datetimeFigureOut">
              <a:rPr lang="nl-NL" smtClean="0"/>
              <a:t>22-9-2025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2E0C73D-629D-57F6-1ECF-C7F9E317E9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CCC6336B-6F9F-8A2C-8116-53555531C5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AB759C3-6127-485D-9145-A7B26E87281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05942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4789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Early diagnosis and intervention in congenital lower urinary tract obstruction: time to revise our approach?</a:t>
            </a:r>
            <a:endParaRPr kumimoji="0" lang="en-GB" sz="2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1" y="1246344"/>
            <a:ext cx="5106766" cy="42139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srgbClr val="003969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ey points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03969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3969"/>
                </a:solidFill>
                <a:effectLst/>
                <a:uLnTx/>
                <a:uFillTx/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Congenital LUTO is a severe, unpredictable condition often diagnosed early in pregnancy, creating significant challenges for both parents and healthcare professionals.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3969"/>
                </a:solidFill>
                <a:effectLst/>
                <a:uLnTx/>
                <a:uFillTx/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Results from previous second-trimester 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srgbClr val="003969"/>
                </a:solidFill>
                <a:effectLst/>
                <a:uLnTx/>
                <a:uFillTx/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vesico</a:t>
            </a:r>
            <a:r>
              <a:rPr lang="nl-NL" sz="1400" dirty="0">
                <a:solidFill>
                  <a:srgbClr val="003969"/>
                </a:solidFill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nl-NL" sz="1400" dirty="0" err="1">
                <a:solidFill>
                  <a:srgbClr val="003969"/>
                </a:solidFill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amniotic</a:t>
            </a:r>
            <a:r>
              <a:rPr lang="nl-NL" sz="1400" dirty="0">
                <a:solidFill>
                  <a:srgbClr val="003969"/>
                </a:solidFill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400" dirty="0" err="1">
                <a:solidFill>
                  <a:srgbClr val="003969"/>
                </a:solidFill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shunting</a:t>
            </a:r>
            <a:r>
              <a:rPr lang="nl-NL" sz="1400" dirty="0">
                <a:solidFill>
                  <a:srgbClr val="003969"/>
                </a:solidFill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 (VAS)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3969"/>
                </a:solidFill>
                <a:effectLst/>
                <a:uLnTx/>
                <a:uFillTx/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 studies were inconclusive, contributing to inconsistent management across fetal intervention centers.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3969"/>
                </a:solidFill>
                <a:effectLst/>
                <a:uLnTx/>
                <a:uFillTx/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Advances in early ultrasound screening and improved shunt technology suggest that early VAS (&lt;17 weeks of gestation) may reduce postnatal morbidity and mortality.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3969"/>
                </a:solidFill>
                <a:effectLst/>
                <a:uLnTx/>
                <a:uFillTx/>
                <a:latin typeface="Calibri" panose="020F0502020204030204"/>
                <a:ea typeface="Arial" panose="020B0604020202020204" pitchFamily="34" charset="0"/>
                <a:cs typeface="Arial" panose="020B0604020202020204" pitchFamily="34" charset="0"/>
              </a:rPr>
              <a:t>Significant gaps remain regarding long-term outcomes, optimal patient selection, and complication risks after early VAS, and these must be addressed through prospective studie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 Light" panose="020F0302020204030204"/>
                <a:ea typeface="+mn-ea"/>
                <a:cs typeface="+mn-cs"/>
              </a:rPr>
              <a:t>Mulder, Kohl et al. 2025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 Light" panose="020F0302020204030204"/>
              <a:ea typeface="+mn-ea"/>
              <a:cs typeface="+mn-cs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AKE HOME MESSAGE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Large-scale, multidisciplinary research is urgently needed before personalized, evidence-based care for fetuses with an early diagnosis of </a:t>
            </a:r>
            <a:r>
              <a:rPr lang="en-US" dirty="0" err="1">
                <a:solidFill>
                  <a:schemeClr val="bg1"/>
                </a:solidFill>
              </a:rPr>
              <a:t>cLUTO</a:t>
            </a:r>
            <a:r>
              <a:rPr lang="en-US" dirty="0">
                <a:solidFill>
                  <a:schemeClr val="bg1"/>
                </a:solidFill>
              </a:rPr>
              <a:t> can be developed.</a:t>
            </a:r>
            <a:endParaRPr lang="nl-NL" dirty="0">
              <a:solidFill>
                <a:schemeClr val="bg1"/>
              </a:solidFill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7" name="Afbeelding 6" descr="Afbeelding met tekst, schets&#10;&#10;Door AI gegenereerde inhoud is mogelijk onjuist.">
            <a:extLst>
              <a:ext uri="{FF2B5EF4-FFF2-40B4-BE49-F238E27FC236}">
                <a16:creationId xmlns:a16="http://schemas.microsoft.com/office/drawing/2014/main" id="{E0EB50DE-286C-1FEF-20FD-CAA580667E8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1" t="57324" r="52771" b="6690"/>
          <a:stretch/>
        </p:blipFill>
        <p:spPr>
          <a:xfrm>
            <a:off x="5366759" y="1958371"/>
            <a:ext cx="3524811" cy="2807594"/>
          </a:xfrm>
          <a:prstGeom prst="rect">
            <a:avLst/>
          </a:prstGeom>
        </p:spPr>
      </p:pic>
      <p:pic>
        <p:nvPicPr>
          <p:cNvPr id="8" name="Afbeelding 7" descr="Afbeelding met tekst, schets&#10;&#10;Door AI gegenereerde inhoud is mogelijk onjuist.">
            <a:extLst>
              <a:ext uri="{FF2B5EF4-FFF2-40B4-BE49-F238E27FC236}">
                <a16:creationId xmlns:a16="http://schemas.microsoft.com/office/drawing/2014/main" id="{B6337705-24F1-E1BF-D1FC-1D46E7356AB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22" t="57324" r="4457" b="6690"/>
          <a:stretch/>
        </p:blipFill>
        <p:spPr>
          <a:xfrm>
            <a:off x="8901192" y="2028872"/>
            <a:ext cx="3163910" cy="2614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155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Calibri Light</vt:lpstr>
      <vt:lpstr>Kantoorthem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estland, R. (Rik)</dc:creator>
  <cp:lastModifiedBy>Laycock, Joseph</cp:lastModifiedBy>
  <cp:revision>3</cp:revision>
  <dcterms:created xsi:type="dcterms:W3CDTF">2025-06-16T09:35:39Z</dcterms:created>
  <dcterms:modified xsi:type="dcterms:W3CDTF">2025-09-22T09:28:41Z</dcterms:modified>
</cp:coreProperties>
</file>